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9144000" cy="6858000" type="screen4x3"/>
  <p:notesSz cx="7023100" cy="9309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1330" y="5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ー サブタイトルの書式設定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786508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586370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560196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684875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335178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829625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048152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07317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149511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39150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887368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467106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611560" y="980728"/>
            <a:ext cx="13219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EV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</p:txBody>
      </p:sp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47370121"/>
              </p:ext>
            </p:extLst>
          </p:nvPr>
        </p:nvGraphicFramePr>
        <p:xfrm>
          <a:off x="1696832" y="1481959"/>
          <a:ext cx="4440760" cy="3387201"/>
        </p:xfrm>
        <a:graphic>
          <a:graphicData uri="http://schemas.openxmlformats.org/drawingml/2006/table">
            <a:tbl>
              <a:tblPr/>
              <a:tblGrid>
                <a:gridCol w="1426788"/>
                <a:gridCol w="191515"/>
                <a:gridCol w="940819"/>
                <a:gridCol w="940819"/>
                <a:gridCol w="940819"/>
              </a:tblGrid>
              <a:tr h="21851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4647"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 weeks after MI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9087"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T </a:t>
                      </a: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fKO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-value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1908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=6)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=5)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46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S (%) </a:t>
                      </a: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7.28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±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.58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±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2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/>
                        </a:rPr>
                        <a:t>p=0.0097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446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VIDd (mm) </a:t>
                      </a: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58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±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82</a:t>
                      </a:r>
                      <a:r>
                        <a:rPr lang="en-US" sz="11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± 0.3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=0.485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6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VIDs (mm) </a:t>
                      </a: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78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±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26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±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=0.329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6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VSd (mm) </a:t>
                      </a: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2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±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5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±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=0.267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6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Wd (mm) </a:t>
                      </a: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15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±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7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±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=0.2096 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76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129" marR="9129" marT="912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9294"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S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, fractional shortening; LVIDd, left ventricular internal diastolic dimension; LVIDS, left ventricular internal systolic </a:t>
                      </a:r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imension, IVSd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, intraventricular septum </a:t>
                      </a:r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iastole</a:t>
                      </a:r>
                      <a:r>
                        <a:rPr lang="en-US" sz="9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:</a:t>
                      </a:r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PWd, posterior wall diastole  </a:t>
                      </a:r>
                    </a:p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44647">
                <a:tc gridSpan="5">
                  <a:txBody>
                    <a:bodyPr/>
                    <a:lstStyle/>
                    <a:p>
                      <a:pPr algn="l" fontAlgn="ctr"/>
                      <a:r>
                        <a:rPr lang="de-DE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/>
                        </a:rPr>
                        <a:t>Unpaired t-test was used for  statistical analysis except LVIDs. LVIDs was</a:t>
                      </a:r>
                      <a:r>
                        <a:rPr lang="de-DE" sz="9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Arial"/>
                        </a:rPr>
                        <a:t> analyzed by </a:t>
                      </a:r>
                      <a:r>
                        <a:rPr lang="de-DE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/>
                        </a:rPr>
                        <a:t>Mann-Whitney test.  Data are shown as mean ± SEM. </a:t>
                      </a:r>
                      <a:endParaRPr lang="de-DE" sz="900" b="0" i="0" u="none" strike="noStrike" dirty="0">
                        <a:solidFill>
                          <a:schemeClr val="tx1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4647"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129" marR="9129" marT="91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4" name="テキスト ボックス 3"/>
          <p:cNvSpPr txBox="1"/>
          <p:nvPr/>
        </p:nvSpPr>
        <p:spPr>
          <a:xfrm>
            <a:off x="1619672" y="1405920"/>
            <a:ext cx="27414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ardiac dimension and function 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30658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5</TotalTime>
  <Words>131</Words>
  <Application>Microsoft Office PowerPoint</Application>
  <PresentationFormat>On-screen Show (4:3)</PresentationFormat>
  <Paragraphs>3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​​テーマ</vt:lpstr>
      <vt:lpstr>PowerPoint Presentation</vt:lpstr>
    </vt:vector>
  </TitlesOfParts>
  <Company>bu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onomi</dc:creator>
  <cp:lastModifiedBy>Whittaker, Linda D</cp:lastModifiedBy>
  <cp:revision>58</cp:revision>
  <cp:lastPrinted>2016-04-22T16:51:03Z</cp:lastPrinted>
  <dcterms:created xsi:type="dcterms:W3CDTF">2015-07-06T18:02:00Z</dcterms:created>
  <dcterms:modified xsi:type="dcterms:W3CDTF">2016-04-22T19:37:40Z</dcterms:modified>
</cp:coreProperties>
</file>